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6"/>
  </p:notesMasterIdLst>
  <p:sldIdLst>
    <p:sldId id="415" r:id="rId2"/>
    <p:sldId id="410" r:id="rId3"/>
    <p:sldId id="397" r:id="rId4"/>
    <p:sldId id="389" r:id="rId5"/>
  </p:sldIdLst>
  <p:sldSz cx="11247438" cy="11430000"/>
  <p:notesSz cx="7315200" cy="9601200"/>
  <p:defaultTextStyle>
    <a:defPPr>
      <a:defRPr lang="en-US"/>
    </a:defPPr>
    <a:lvl1pPr marL="0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1pPr>
    <a:lvl2pPr marL="401656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2pPr>
    <a:lvl3pPr marL="803311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3pPr>
    <a:lvl4pPr marL="1204970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4pPr>
    <a:lvl5pPr marL="1606623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5pPr>
    <a:lvl6pPr marL="2008277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6pPr>
    <a:lvl7pPr marL="2409937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7pPr>
    <a:lvl8pPr marL="2811594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8pPr>
    <a:lvl9pPr marL="3213247" algn="l" defTabSz="803311" rtl="0" eaLnBrk="1" latinLnBrk="0" hangingPunct="1">
      <a:defRPr sz="158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99" userDrawn="1">
          <p15:clr>
            <a:srgbClr val="A4A3A4"/>
          </p15:clr>
        </p15:guide>
        <p15:guide id="2" pos="35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80" autoAdjust="0"/>
    <p:restoredTop sz="94630" autoAdjust="0"/>
  </p:normalViewPr>
  <p:slideViewPr>
    <p:cSldViewPr snapToGrid="0">
      <p:cViewPr varScale="1">
        <p:scale>
          <a:sx n="54" d="100"/>
          <a:sy n="54" d="100"/>
        </p:scale>
        <p:origin x="1914" y="72"/>
      </p:cViewPr>
      <p:guideLst>
        <p:guide orient="horz" pos="3599"/>
        <p:guide pos="35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notesMaster" Target="notesMasters/notesMaster1.xml"/>
   <Relationship Id="rId7" Type="http://schemas.openxmlformats.org/officeDocument/2006/relationships/presProps" Target="presProps.xml"/>
   <Relationship Id="rId8" Type="http://schemas.openxmlformats.org/officeDocument/2006/relationships/viewProps" Target="viewProps.xml"/>
   <Relationship Id="rId9" Type="http://schemas.openxmlformats.org/officeDocument/2006/relationships/theme" Target="theme/theme1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8"/>
          </a:xfrm>
          <a:prstGeom prst="rect">
            <a:avLst/>
          </a:prstGeom>
        </p:spPr>
        <p:txBody>
          <a:bodyPr vert="horz" lIns="96663" tIns="48332" rIns="96663" bIns="48332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8" y="0"/>
            <a:ext cx="3169920" cy="481728"/>
          </a:xfrm>
          <a:prstGeom prst="rect">
            <a:avLst/>
          </a:prstGeom>
        </p:spPr>
        <p:txBody>
          <a:bodyPr vert="horz" lIns="96663" tIns="48332" rIns="96663" bIns="48332" rtlCol="0"/>
          <a:lstStyle>
            <a:lvl1pPr algn="r">
              <a:defRPr sz="1300"/>
            </a:lvl1pPr>
          </a:lstStyle>
          <a:p>
            <a:fld id="{E852BACA-07A1-490E-B24F-F3A3BBB4A5F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3750" y="1200150"/>
            <a:ext cx="318770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3" tIns="48332" rIns="96663" bIns="4833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1" y="4620578"/>
            <a:ext cx="5852160" cy="3780473"/>
          </a:xfrm>
          <a:prstGeom prst="rect">
            <a:avLst/>
          </a:prstGeom>
        </p:spPr>
        <p:txBody>
          <a:bodyPr vert="horz" lIns="96663" tIns="48332" rIns="96663" bIns="4833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1727"/>
          </a:xfrm>
          <a:prstGeom prst="rect">
            <a:avLst/>
          </a:prstGeom>
        </p:spPr>
        <p:txBody>
          <a:bodyPr vert="horz" lIns="96663" tIns="48332" rIns="96663" bIns="48332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8" y="9119475"/>
            <a:ext cx="3169920" cy="481727"/>
          </a:xfrm>
          <a:prstGeom prst="rect">
            <a:avLst/>
          </a:prstGeom>
        </p:spPr>
        <p:txBody>
          <a:bodyPr vert="horz" lIns="96663" tIns="48332" rIns="96663" bIns="48332" rtlCol="0" anchor="b"/>
          <a:lstStyle>
            <a:lvl1pPr algn="r">
              <a:defRPr sz="1300"/>
            </a:lvl1pPr>
          </a:lstStyle>
          <a:p>
            <a:fld id="{15E65DE6-6CA2-493C-822A-7C2BB2514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2593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1pPr>
    <a:lvl2pPr marL="401656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2pPr>
    <a:lvl3pPr marL="803311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3pPr>
    <a:lvl4pPr marL="1204970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4pPr>
    <a:lvl5pPr marL="1606623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5pPr>
    <a:lvl6pPr marL="2008277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6pPr>
    <a:lvl7pPr marL="2409937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7pPr>
    <a:lvl8pPr marL="2811594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8pPr>
    <a:lvl9pPr marL="3213247" algn="l" defTabSz="803311" rtl="0" eaLnBrk="1" latinLnBrk="0" hangingPunct="1">
      <a:defRPr sz="105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43558" y="1870607"/>
            <a:ext cx="9560322" cy="3979333"/>
          </a:xfrm>
        </p:spPr>
        <p:txBody>
          <a:bodyPr anchor="b"/>
          <a:lstStyle>
            <a:lvl1pPr algn="ctr">
              <a:defRPr sz="73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05931" y="6003397"/>
            <a:ext cx="8435579" cy="2759603"/>
          </a:xfrm>
        </p:spPr>
        <p:txBody>
          <a:bodyPr/>
          <a:lstStyle>
            <a:lvl1pPr marL="0" indent="0" algn="ctr">
              <a:buNone/>
              <a:defRPr sz="2952"/>
            </a:lvl1pPr>
            <a:lvl2pPr marL="562202" indent="0" algn="ctr">
              <a:buNone/>
              <a:defRPr sz="2460"/>
            </a:lvl2pPr>
            <a:lvl3pPr marL="1124402" indent="0" algn="ctr">
              <a:buNone/>
              <a:defRPr sz="2214"/>
            </a:lvl3pPr>
            <a:lvl4pPr marL="1686601" indent="0" algn="ctr">
              <a:buNone/>
              <a:defRPr sz="1968"/>
            </a:lvl4pPr>
            <a:lvl5pPr marL="2248804" indent="0" algn="ctr">
              <a:buNone/>
              <a:defRPr sz="1968"/>
            </a:lvl5pPr>
            <a:lvl6pPr marL="2811003" indent="0" algn="ctr">
              <a:buNone/>
              <a:defRPr sz="1968"/>
            </a:lvl6pPr>
            <a:lvl7pPr marL="3373206" indent="0" algn="ctr">
              <a:buNone/>
              <a:defRPr sz="1968"/>
            </a:lvl7pPr>
            <a:lvl8pPr marL="3935405" indent="0" algn="ctr">
              <a:buNone/>
              <a:defRPr sz="1968"/>
            </a:lvl8pPr>
            <a:lvl9pPr marL="4497607" indent="0" algn="ctr">
              <a:buNone/>
              <a:defRPr sz="1968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41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71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048949" y="608542"/>
            <a:ext cx="2425228" cy="968639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3263" y="608542"/>
            <a:ext cx="7135092" cy="968639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758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341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7411" y="2849567"/>
            <a:ext cx="9700915" cy="4754563"/>
          </a:xfrm>
        </p:spPr>
        <p:txBody>
          <a:bodyPr anchor="b"/>
          <a:lstStyle>
            <a:lvl1pPr>
              <a:defRPr sz="73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7411" y="7649107"/>
            <a:ext cx="9700915" cy="2500313"/>
          </a:xfrm>
        </p:spPr>
        <p:txBody>
          <a:bodyPr/>
          <a:lstStyle>
            <a:lvl1pPr marL="0" indent="0">
              <a:buNone/>
              <a:defRPr sz="2952">
                <a:solidFill>
                  <a:schemeClr val="tx1"/>
                </a:solidFill>
              </a:defRPr>
            </a:lvl1pPr>
            <a:lvl2pPr marL="562202" indent="0">
              <a:buNone/>
              <a:defRPr sz="2460">
                <a:solidFill>
                  <a:schemeClr val="tx1">
                    <a:tint val="75000"/>
                  </a:schemeClr>
                </a:solidFill>
              </a:defRPr>
            </a:lvl2pPr>
            <a:lvl3pPr marL="1124402" indent="0">
              <a:buNone/>
              <a:defRPr sz="2214">
                <a:solidFill>
                  <a:schemeClr val="tx1">
                    <a:tint val="75000"/>
                  </a:schemeClr>
                </a:solidFill>
              </a:defRPr>
            </a:lvl3pPr>
            <a:lvl4pPr marL="1686601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4pPr>
            <a:lvl5pPr marL="2248804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5pPr>
            <a:lvl6pPr marL="2811003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6pPr>
            <a:lvl7pPr marL="337320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7pPr>
            <a:lvl8pPr marL="3935405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8pPr>
            <a:lvl9pPr marL="4497607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526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3262" y="3042708"/>
            <a:ext cx="4780161" cy="725223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94016" y="3042708"/>
            <a:ext cx="4780161" cy="725223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163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4734" y="608547"/>
            <a:ext cx="9700915" cy="220927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4736" y="2801939"/>
            <a:ext cx="4758193" cy="1373188"/>
          </a:xfrm>
        </p:spPr>
        <p:txBody>
          <a:bodyPr anchor="b"/>
          <a:lstStyle>
            <a:lvl1pPr marL="0" indent="0">
              <a:buNone/>
              <a:defRPr sz="2952" b="1"/>
            </a:lvl1pPr>
            <a:lvl2pPr marL="562202" indent="0">
              <a:buNone/>
              <a:defRPr sz="2460" b="1"/>
            </a:lvl2pPr>
            <a:lvl3pPr marL="1124402" indent="0">
              <a:buNone/>
              <a:defRPr sz="2214" b="1"/>
            </a:lvl3pPr>
            <a:lvl4pPr marL="1686601" indent="0">
              <a:buNone/>
              <a:defRPr sz="1968" b="1"/>
            </a:lvl4pPr>
            <a:lvl5pPr marL="2248804" indent="0">
              <a:buNone/>
              <a:defRPr sz="1968" b="1"/>
            </a:lvl5pPr>
            <a:lvl6pPr marL="2811003" indent="0">
              <a:buNone/>
              <a:defRPr sz="1968" b="1"/>
            </a:lvl6pPr>
            <a:lvl7pPr marL="3373206" indent="0">
              <a:buNone/>
              <a:defRPr sz="1968" b="1"/>
            </a:lvl7pPr>
            <a:lvl8pPr marL="3935405" indent="0">
              <a:buNone/>
              <a:defRPr sz="1968" b="1"/>
            </a:lvl8pPr>
            <a:lvl9pPr marL="4497607" indent="0">
              <a:buNone/>
              <a:defRPr sz="196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4736" y="4175126"/>
            <a:ext cx="4758193" cy="614098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94020" y="2801939"/>
            <a:ext cx="4781626" cy="1373188"/>
          </a:xfrm>
        </p:spPr>
        <p:txBody>
          <a:bodyPr anchor="b"/>
          <a:lstStyle>
            <a:lvl1pPr marL="0" indent="0">
              <a:buNone/>
              <a:defRPr sz="2952" b="1"/>
            </a:lvl1pPr>
            <a:lvl2pPr marL="562202" indent="0">
              <a:buNone/>
              <a:defRPr sz="2460" b="1"/>
            </a:lvl2pPr>
            <a:lvl3pPr marL="1124402" indent="0">
              <a:buNone/>
              <a:defRPr sz="2214" b="1"/>
            </a:lvl3pPr>
            <a:lvl4pPr marL="1686601" indent="0">
              <a:buNone/>
              <a:defRPr sz="1968" b="1"/>
            </a:lvl4pPr>
            <a:lvl5pPr marL="2248804" indent="0">
              <a:buNone/>
              <a:defRPr sz="1968" b="1"/>
            </a:lvl5pPr>
            <a:lvl6pPr marL="2811003" indent="0">
              <a:buNone/>
              <a:defRPr sz="1968" b="1"/>
            </a:lvl6pPr>
            <a:lvl7pPr marL="3373206" indent="0">
              <a:buNone/>
              <a:defRPr sz="1968" b="1"/>
            </a:lvl7pPr>
            <a:lvl8pPr marL="3935405" indent="0">
              <a:buNone/>
              <a:defRPr sz="1968" b="1"/>
            </a:lvl8pPr>
            <a:lvl9pPr marL="4497607" indent="0">
              <a:buNone/>
              <a:defRPr sz="196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94020" y="4175126"/>
            <a:ext cx="4781626" cy="614098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051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189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524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4725" y="762000"/>
            <a:ext cx="3627592" cy="2667000"/>
          </a:xfrm>
        </p:spPr>
        <p:txBody>
          <a:bodyPr anchor="b"/>
          <a:lstStyle>
            <a:lvl1pPr>
              <a:defRPr sz="393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1627" y="1645711"/>
            <a:ext cx="5694015" cy="8122708"/>
          </a:xfrm>
        </p:spPr>
        <p:txBody>
          <a:bodyPr/>
          <a:lstStyle>
            <a:lvl1pPr>
              <a:defRPr sz="3936"/>
            </a:lvl1pPr>
            <a:lvl2pPr>
              <a:defRPr sz="3444"/>
            </a:lvl2pPr>
            <a:lvl3pPr>
              <a:defRPr sz="2952"/>
            </a:lvl3pPr>
            <a:lvl4pPr>
              <a:defRPr sz="2460"/>
            </a:lvl4pPr>
            <a:lvl5pPr>
              <a:defRPr sz="2460"/>
            </a:lvl5pPr>
            <a:lvl6pPr>
              <a:defRPr sz="2460"/>
            </a:lvl6pPr>
            <a:lvl7pPr>
              <a:defRPr sz="2460"/>
            </a:lvl7pPr>
            <a:lvl8pPr>
              <a:defRPr sz="2460"/>
            </a:lvl8pPr>
            <a:lvl9pPr>
              <a:defRPr sz="246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4725" y="3429000"/>
            <a:ext cx="3627592" cy="6352648"/>
          </a:xfrm>
        </p:spPr>
        <p:txBody>
          <a:bodyPr/>
          <a:lstStyle>
            <a:lvl1pPr marL="0" indent="0">
              <a:buNone/>
              <a:defRPr sz="1968"/>
            </a:lvl1pPr>
            <a:lvl2pPr marL="562202" indent="0">
              <a:buNone/>
              <a:defRPr sz="1722"/>
            </a:lvl2pPr>
            <a:lvl3pPr marL="1124402" indent="0">
              <a:buNone/>
              <a:defRPr sz="1476"/>
            </a:lvl3pPr>
            <a:lvl4pPr marL="1686601" indent="0">
              <a:buNone/>
              <a:defRPr sz="1230"/>
            </a:lvl4pPr>
            <a:lvl5pPr marL="2248804" indent="0">
              <a:buNone/>
              <a:defRPr sz="1230"/>
            </a:lvl5pPr>
            <a:lvl6pPr marL="2811003" indent="0">
              <a:buNone/>
              <a:defRPr sz="1230"/>
            </a:lvl6pPr>
            <a:lvl7pPr marL="3373206" indent="0">
              <a:buNone/>
              <a:defRPr sz="1230"/>
            </a:lvl7pPr>
            <a:lvl8pPr marL="3935405" indent="0">
              <a:buNone/>
              <a:defRPr sz="1230"/>
            </a:lvl8pPr>
            <a:lvl9pPr marL="4497607" indent="0">
              <a:buNone/>
              <a:defRPr sz="123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866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4725" y="762000"/>
            <a:ext cx="3627592" cy="2667000"/>
          </a:xfrm>
        </p:spPr>
        <p:txBody>
          <a:bodyPr anchor="b"/>
          <a:lstStyle>
            <a:lvl1pPr>
              <a:defRPr sz="393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81627" y="1645711"/>
            <a:ext cx="5694015" cy="8122708"/>
          </a:xfrm>
        </p:spPr>
        <p:txBody>
          <a:bodyPr anchor="t"/>
          <a:lstStyle>
            <a:lvl1pPr marL="0" indent="0">
              <a:buNone/>
              <a:defRPr sz="3936"/>
            </a:lvl1pPr>
            <a:lvl2pPr marL="562202" indent="0">
              <a:buNone/>
              <a:defRPr sz="3444"/>
            </a:lvl2pPr>
            <a:lvl3pPr marL="1124402" indent="0">
              <a:buNone/>
              <a:defRPr sz="2952"/>
            </a:lvl3pPr>
            <a:lvl4pPr marL="1686601" indent="0">
              <a:buNone/>
              <a:defRPr sz="2460"/>
            </a:lvl4pPr>
            <a:lvl5pPr marL="2248804" indent="0">
              <a:buNone/>
              <a:defRPr sz="2460"/>
            </a:lvl5pPr>
            <a:lvl6pPr marL="2811003" indent="0">
              <a:buNone/>
              <a:defRPr sz="2460"/>
            </a:lvl6pPr>
            <a:lvl7pPr marL="3373206" indent="0">
              <a:buNone/>
              <a:defRPr sz="2460"/>
            </a:lvl7pPr>
            <a:lvl8pPr marL="3935405" indent="0">
              <a:buNone/>
              <a:defRPr sz="2460"/>
            </a:lvl8pPr>
            <a:lvl9pPr marL="4497607" indent="0">
              <a:buNone/>
              <a:defRPr sz="246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4725" y="3429000"/>
            <a:ext cx="3627592" cy="6352648"/>
          </a:xfrm>
        </p:spPr>
        <p:txBody>
          <a:bodyPr/>
          <a:lstStyle>
            <a:lvl1pPr marL="0" indent="0">
              <a:buNone/>
              <a:defRPr sz="1968"/>
            </a:lvl1pPr>
            <a:lvl2pPr marL="562202" indent="0">
              <a:buNone/>
              <a:defRPr sz="1722"/>
            </a:lvl2pPr>
            <a:lvl3pPr marL="1124402" indent="0">
              <a:buNone/>
              <a:defRPr sz="1476"/>
            </a:lvl3pPr>
            <a:lvl4pPr marL="1686601" indent="0">
              <a:buNone/>
              <a:defRPr sz="1230"/>
            </a:lvl4pPr>
            <a:lvl5pPr marL="2248804" indent="0">
              <a:buNone/>
              <a:defRPr sz="1230"/>
            </a:lvl5pPr>
            <a:lvl6pPr marL="2811003" indent="0">
              <a:buNone/>
              <a:defRPr sz="1230"/>
            </a:lvl6pPr>
            <a:lvl7pPr marL="3373206" indent="0">
              <a:buNone/>
              <a:defRPr sz="1230"/>
            </a:lvl7pPr>
            <a:lvl8pPr marL="3935405" indent="0">
              <a:buNone/>
              <a:defRPr sz="1230"/>
            </a:lvl8pPr>
            <a:lvl9pPr marL="4497607" indent="0">
              <a:buNone/>
              <a:defRPr sz="123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D8B9C-1EC5-4D4E-9233-738FF80A8A04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14AF6-68D7-41E1-AE8E-AD4E10DF2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76700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3270" y="608547"/>
            <a:ext cx="9700915" cy="22092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3270" y="3042708"/>
            <a:ext cx="9700915" cy="72522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3260" y="10593922"/>
            <a:ext cx="2530674" cy="6085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B5A7C-55D3-4A15-8ADB-17BAFD6B4EE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9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25717" y="10593922"/>
            <a:ext cx="3796010" cy="6085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943504" y="10593922"/>
            <a:ext cx="2530674" cy="6085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7CF09-D3B5-4B60-841E-4DC16B64F9C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2851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124402" rtl="0" eaLnBrk="1" latinLnBrk="0" hangingPunct="1">
        <a:lnSpc>
          <a:spcPct val="90000"/>
        </a:lnSpc>
        <a:spcBef>
          <a:spcPct val="0"/>
        </a:spcBef>
        <a:buNone/>
        <a:defRPr sz="54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1101" indent="-281101" algn="l" defTabSz="1124402" rtl="0" eaLnBrk="1" latinLnBrk="0" hangingPunct="1">
        <a:lnSpc>
          <a:spcPct val="90000"/>
        </a:lnSpc>
        <a:spcBef>
          <a:spcPts val="1230"/>
        </a:spcBef>
        <a:buFont typeface="Arial" panose="020B0604020202020204" pitchFamily="34" charset="0"/>
        <a:buChar char="•"/>
        <a:defRPr sz="3444" kern="1200">
          <a:solidFill>
            <a:schemeClr val="tx1"/>
          </a:solidFill>
          <a:latin typeface="+mn-lt"/>
          <a:ea typeface="+mn-ea"/>
          <a:cs typeface="+mn-cs"/>
        </a:defRPr>
      </a:lvl1pPr>
      <a:lvl2pPr marL="843303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952" kern="1200">
          <a:solidFill>
            <a:schemeClr val="tx1"/>
          </a:solidFill>
          <a:latin typeface="+mn-lt"/>
          <a:ea typeface="+mn-ea"/>
          <a:cs typeface="+mn-cs"/>
        </a:defRPr>
      </a:lvl2pPr>
      <a:lvl3pPr marL="1405501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460" kern="1200">
          <a:solidFill>
            <a:schemeClr val="tx1"/>
          </a:solidFill>
          <a:latin typeface="+mn-lt"/>
          <a:ea typeface="+mn-ea"/>
          <a:cs typeface="+mn-cs"/>
        </a:defRPr>
      </a:lvl3pPr>
      <a:lvl4pPr marL="1967703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4pPr>
      <a:lvl5pPr marL="2529903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5pPr>
      <a:lvl6pPr marL="3092105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6pPr>
      <a:lvl7pPr marL="3654305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7pPr>
      <a:lvl8pPr marL="4216506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8pPr>
      <a:lvl9pPr marL="4778707" indent="-281101" algn="l" defTabSz="1124402" rtl="0" eaLnBrk="1" latinLnBrk="0" hangingPunct="1">
        <a:lnSpc>
          <a:spcPct val="90000"/>
        </a:lnSpc>
        <a:spcBef>
          <a:spcPts val="615"/>
        </a:spcBef>
        <a:buFont typeface="Arial" panose="020B0604020202020204" pitchFamily="34" charset="0"/>
        <a:buChar char="•"/>
        <a:defRPr sz="22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1pPr>
      <a:lvl2pPr marL="562202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2pPr>
      <a:lvl3pPr marL="1124402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3pPr>
      <a:lvl4pPr marL="1686601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4pPr>
      <a:lvl5pPr marL="2248804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5pPr>
      <a:lvl6pPr marL="2811003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6pPr>
      <a:lvl7pPr marL="3373206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7pPr>
      <a:lvl8pPr marL="3935405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8pPr>
      <a:lvl9pPr marL="4497607" algn="l" defTabSz="1124402" rtl="0" eaLnBrk="1" latinLnBrk="0" hangingPunct="1">
        <a:defRPr sz="22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png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2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3.png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4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78881" y="686074"/>
            <a:ext cx="2862101" cy="3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73112" y="1329459"/>
            <a:ext cx="9973443" cy="91951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9991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016954" y="1752029"/>
            <a:ext cx="9701212" cy="521912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6558" y="268941"/>
            <a:ext cx="3470932" cy="3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31578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3083" y="215109"/>
            <a:ext cx="2187388" cy="3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3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Content Placeholder 12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73113" y="1034808"/>
            <a:ext cx="9998075" cy="9062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5038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90630" y="546100"/>
            <a:ext cx="8066177" cy="974883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26558" y="210495"/>
            <a:ext cx="2772454" cy="3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982853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945</TotalTime>
  <Words>12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6-05-20T11:26:45Z</cp:lastPrinted>
</cp:coreProperties>
</file>